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Medium Style 4 –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BDBED569-4797-4DF1-A0F4-6AAB3CD982D8}" styleName="Light Style 3 –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A488322-F2BA-4B5B-9748-0D474271808F}" styleName="Medium Style 3 –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4C1A8A3-306A-4EB7-A6B1-4F7E0EB9C5D6}" styleName="Medium Style 3 –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ishah Aljarallah" userId="6a7063dd-ac87-46d0-a4c6-f3e5188f5ec6" providerId="ADAL" clId="{F498C999-E047-4DDD-86E7-98CF57F26875}"/>
    <pc:docChg chg="modSld">
      <pc:chgData name="Aishah Aljarallah" userId="6a7063dd-ac87-46d0-a4c6-f3e5188f5ec6" providerId="ADAL" clId="{F498C999-E047-4DDD-86E7-98CF57F26875}" dt="2024-02-15T09:49:38.721" v="2" actId="14100"/>
      <pc:docMkLst>
        <pc:docMk/>
      </pc:docMkLst>
      <pc:sldChg chg="modSp mod">
        <pc:chgData name="Aishah Aljarallah" userId="6a7063dd-ac87-46d0-a4c6-f3e5188f5ec6" providerId="ADAL" clId="{F498C999-E047-4DDD-86E7-98CF57F26875}" dt="2024-02-15T09:44:25.013" v="0" actId="1076"/>
        <pc:sldMkLst>
          <pc:docMk/>
          <pc:sldMk cId="1964565981" sldId="257"/>
        </pc:sldMkLst>
        <pc:spChg chg="mod">
          <ac:chgData name="Aishah Aljarallah" userId="6a7063dd-ac87-46d0-a4c6-f3e5188f5ec6" providerId="ADAL" clId="{F498C999-E047-4DDD-86E7-98CF57F26875}" dt="2024-02-15T09:44:25.013" v="0" actId="1076"/>
          <ac:spMkLst>
            <pc:docMk/>
            <pc:sldMk cId="1964565981" sldId="257"/>
            <ac:spMk id="4" creationId="{05842B7B-85C6-40DC-9309-7DE0CB7B8626}"/>
          </ac:spMkLst>
        </pc:spChg>
      </pc:sldChg>
      <pc:sldChg chg="modSp mod">
        <pc:chgData name="Aishah Aljarallah" userId="6a7063dd-ac87-46d0-a4c6-f3e5188f5ec6" providerId="ADAL" clId="{F498C999-E047-4DDD-86E7-98CF57F26875}" dt="2024-02-15T09:49:38.721" v="2" actId="14100"/>
        <pc:sldMkLst>
          <pc:docMk/>
          <pc:sldMk cId="2068059029" sldId="260"/>
        </pc:sldMkLst>
        <pc:graphicFrameChg chg="mod modGraphic">
          <ac:chgData name="Aishah Aljarallah" userId="6a7063dd-ac87-46d0-a4c6-f3e5188f5ec6" providerId="ADAL" clId="{F498C999-E047-4DDD-86E7-98CF57F26875}" dt="2024-02-15T09:49:38.721" v="2" actId="14100"/>
          <ac:graphicFrameMkLst>
            <pc:docMk/>
            <pc:sldMk cId="2068059029" sldId="260"/>
            <ac:graphicFrameMk id="4" creationId="{1F5203B3-37B4-48C7-ADF8-544396D22E26}"/>
          </ac:graphicFrameMkLst>
        </pc:graphicFrameChg>
      </pc:sldChg>
    </pc:docChg>
  </pc:docChgLst>
  <pc:docChgLst>
    <pc:chgData name="Aishah Aljarallah" userId="6a7063dd-ac87-46d0-a4c6-f3e5188f5ec6" providerId="ADAL" clId="{21A17862-7F9E-43BB-9352-A015D12E3288}"/>
    <pc:docChg chg="delSld">
      <pc:chgData name="Aishah Aljarallah" userId="6a7063dd-ac87-46d0-a4c6-f3e5188f5ec6" providerId="ADAL" clId="{21A17862-7F9E-43BB-9352-A015D12E3288}" dt="2024-03-25T08:40:25.952" v="0" actId="47"/>
      <pc:docMkLst>
        <pc:docMk/>
      </pc:docMkLst>
      <pc:sldChg chg="del">
        <pc:chgData name="Aishah Aljarallah" userId="6a7063dd-ac87-46d0-a4c6-f3e5188f5ec6" providerId="ADAL" clId="{21A17862-7F9E-43BB-9352-A015D12E3288}" dt="2024-03-25T08:40:25.952" v="0" actId="47"/>
        <pc:sldMkLst>
          <pc:docMk/>
          <pc:sldMk cId="1964565981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55A19E-DD72-40C8-BB1D-A4E1238D93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6DA9CF2-4CC1-4BCD-8C90-27826304E8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B59A64-36AD-43A0-A7E7-F90C79FDFA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CA0C3-5897-4A69-98BA-0B251CB6D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A51A44-35A0-4AF7-A95D-897D1DF9E3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154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E7E57-BF6C-4AF9-9039-7488FF2E5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38D0A9-45D6-4A8B-8211-7057A579DE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07846E-47EC-47EA-A5B4-286C8ACD3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D7D5ED-E8B4-488C-B46C-A14AB572E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34DE3C-00DD-4495-95F0-971E7A6DE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5443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643F78-39A6-4872-973A-D0E68B44CA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A073E6-61C0-4DB5-BBBD-0C4885F776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EAD74D-B730-465D-8D6D-33E87CBBB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666CFA-EECE-428A-AB9C-639E5A434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C3D0A2-9594-4BE2-AB54-3345B2497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62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C0B735-C893-4532-93CF-2DDE6A59EC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636F36-50BD-4491-B9B2-F7F975B3E2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88949-2EDE-4630-83E5-CC37C013D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4B26B8-7F15-4C1A-86D6-9C693AD9C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A4D4E2-16F7-42C3-B5EF-F337E38F5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004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AA197C-9711-490A-BE80-8D22FBF75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53F845-C4B7-4F7A-85CD-A6D9A54A7A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81907-99EA-49D5-B0EB-AB0A71B3C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8523D-565D-4C08-9C3D-9A8A62E5FD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5BC618-95F4-49D2-AF49-1A3B1D3DD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53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CA4A3-20AE-4A37-9B3B-CB2904C70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53C1A8-8D66-40DB-952D-AB106195169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72FC0E-47A2-4357-9D05-282ACB1565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EBA6B8-45D9-4A60-A259-EAD8D5B190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2974B5-9167-4E0C-85DD-1ADCE3085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D806AC-4634-4725-9B4A-0E7F40B09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98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806E6-B017-4574-A78E-AC43378AC5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380241-3DDE-4348-BF36-C022A13B3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657AF5-DA97-4823-8432-9246C1D05D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3CACA0-0F1D-48BF-8E33-2DCF7AAD21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DE6A32-215F-406B-93C1-EF77511BC3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329D353-1C0F-4662-A367-719B1D6BD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8CB9EC1-80DE-4CF5-9482-3D15266CC6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36B1622-EE3A-48F7-86FB-702EA82B6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3DAA3C-73A5-4432-B7E8-E7CE2D5A5B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850CA1-6A06-4336-A2CA-CBD254EAB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D0BB1C6-0698-41B7-BFB1-08E768968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C04CDBA-4AF2-4D63-B55A-67D83B1A4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7667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6F5E4A-4514-4590-BE11-A8A7CAFF4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0FE66C-7C8C-4C1B-95DD-F96CBCB1D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77175C4-E9B3-482B-9E14-7756A447B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7710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A12A96-7787-4AFA-92B1-7A2E1E06D5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72B098-D13A-403F-BAF8-8AEB9EBBBC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2238AB-5945-4058-A8DC-151C9C077A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199258-2C7B-435B-8DB0-9E3CCF33D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CB963E-B413-4FD8-A43F-9CF1BC8D2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BDA331-3A92-4E27-8BB0-A616A6E94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736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42666-FDD0-451A-83F8-77E2A5CE6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0BCBAB-7E7C-4318-BCE5-8D0C46D02A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CEDF8E-FCCF-4122-9BB8-244A4B1EED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D46CD1-56F1-4D7D-9888-7F02DD2E80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B0B9D5-7292-4F1F-AE73-E47E46D62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242BCC-6215-4A6B-B1A5-E6E1EBEFA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983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563C1A-94DC-4857-8508-5CB8739925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077F37-852F-44F1-A7BB-8ED117FBE0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540227-70D3-45E8-B6CF-BA8EB35FDB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165768-A05A-44B6-A25A-355615E9AA35}" type="datetimeFigureOut">
              <a:rPr lang="en-US" smtClean="0"/>
              <a:t>2024-04-0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38D909-DCC5-430E-B941-8D22E8FAD6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FEB667-5EF6-4BB1-8CA9-57C0A107B8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5B27C-39E5-49A0-B83D-645058FB4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996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9B0AE8D-9E10-4E09-87CA-3A1021F6C7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29965139"/>
              </p:ext>
            </p:extLst>
          </p:nvPr>
        </p:nvGraphicFramePr>
        <p:xfrm>
          <a:off x="2165510" y="1214885"/>
          <a:ext cx="4055676" cy="3173851"/>
        </p:xfrm>
        <a:graphic>
          <a:graphicData uri="http://schemas.openxmlformats.org/drawingml/2006/table">
            <a:tbl>
              <a:tblPr>
                <a:tableStyleId>{74C1A8A3-306A-4EB7-A6B1-4F7E0EB9C5D6}</a:tableStyleId>
              </a:tblPr>
              <a:tblGrid>
                <a:gridCol w="2794838">
                  <a:extLst>
                    <a:ext uri="{9D8B030D-6E8A-4147-A177-3AD203B41FA5}">
                      <a16:colId xmlns:a16="http://schemas.microsoft.com/office/drawing/2014/main" val="284594700"/>
                    </a:ext>
                  </a:extLst>
                </a:gridCol>
                <a:gridCol w="1260838">
                  <a:extLst>
                    <a:ext uri="{9D8B030D-6E8A-4147-A177-3AD203B41FA5}">
                      <a16:colId xmlns:a16="http://schemas.microsoft.com/office/drawing/2014/main" val="1418704052"/>
                    </a:ext>
                  </a:extLst>
                </a:gridCol>
              </a:tblGrid>
              <a:tr h="25729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WKY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Mean ± SEM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985427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Systolic blood pressure (mmHg)</a:t>
                      </a:r>
                    </a:p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Diastolic blood pressure (mmHg)</a:t>
                      </a:r>
                    </a:p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Heart weight (g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4 ± 3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3 ± 4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.50 ± 0.03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506280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Body weight (g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292.8 ± 5.55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874092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Tibia length (cm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3.42 ± 0.0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7435074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Heart weight / Body weigh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0.005 ± 0.0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7065029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Heart weight / Tibia length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0.432 ±0.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57547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SHR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027417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Systolic blood pressure (mmHg)</a:t>
                      </a:r>
                    </a:p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Diastolic blood pressure (mmHg)</a:t>
                      </a:r>
                    </a:p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Heart weight (g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84 ± 3.7</a:t>
                      </a:r>
                      <a:r>
                        <a:rPr lang="en-US" sz="12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*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26 ± 3.7</a:t>
                      </a:r>
                      <a:r>
                        <a:rPr lang="en-US" sz="1200" b="0" u="none" strike="noStrike" dirty="0">
                          <a:solidFill>
                            <a:srgbClr val="FF0000"/>
                          </a:solidFill>
                          <a:effectLst/>
                        </a:rPr>
                        <a:t>*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1.59 ± 0.05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24423569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Body weight (g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280.66 ± 5.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3756484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Tibia length (cm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3.45 ± 0.0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7707275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Heart weight / Body weigh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0.0057 ± 0.0001</a:t>
                      </a:r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*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5375879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lvl="1" algn="l" fontAlgn="b"/>
                      <a:r>
                        <a:rPr lang="en-US" sz="1200" u="none" strike="noStrike" dirty="0">
                          <a:effectLst/>
                        </a:rPr>
                        <a:t>Heart weight / Tibia length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</a:rPr>
                        <a:t>0.47 ± 0.016 </a:t>
                      </a:r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**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2349232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8572E3F-3264-4AEC-868C-505C973BAAAF}"/>
              </a:ext>
            </a:extLst>
          </p:cNvPr>
          <p:cNvSpPr txBox="1"/>
          <p:nvPr/>
        </p:nvSpPr>
        <p:spPr>
          <a:xfrm>
            <a:off x="2266961" y="4472058"/>
            <a:ext cx="27709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** </a:t>
            </a:r>
            <a:r>
              <a:rPr lang="en-US" sz="1200" dirty="0"/>
              <a:t>P &lt; 0.01 vs WKY</a:t>
            </a:r>
          </a:p>
          <a:p>
            <a:r>
              <a:rPr lang="en-US" sz="1200" dirty="0">
                <a:solidFill>
                  <a:srgbClr val="FF0000"/>
                </a:solidFill>
              </a:rPr>
              <a:t>*** </a:t>
            </a:r>
            <a:r>
              <a:rPr lang="en-US" sz="1200" dirty="0"/>
              <a:t>P &lt; 0.001 vs WKY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5A609F5-4CA8-470C-81FD-8F9885CAB719}"/>
              </a:ext>
            </a:extLst>
          </p:cNvPr>
          <p:cNvSpPr txBox="1"/>
          <p:nvPr/>
        </p:nvSpPr>
        <p:spPr>
          <a:xfrm>
            <a:off x="665018" y="473193"/>
            <a:ext cx="6899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Table-S1: Blood pressure, body weight and heart weight of WKY and SHR</a:t>
            </a:r>
          </a:p>
        </p:txBody>
      </p:sp>
    </p:spTree>
    <p:extLst>
      <p:ext uri="{BB962C8B-B14F-4D97-AF65-F5344CB8AC3E}">
        <p14:creationId xmlns:p14="http://schemas.microsoft.com/office/powerpoint/2010/main" val="20401278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1F5203B3-37B4-48C7-ADF8-544396D22E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7791448"/>
              </p:ext>
            </p:extLst>
          </p:nvPr>
        </p:nvGraphicFramePr>
        <p:xfrm>
          <a:off x="908338" y="1398854"/>
          <a:ext cx="6443808" cy="448056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3705239">
                  <a:extLst>
                    <a:ext uri="{9D8B030D-6E8A-4147-A177-3AD203B41FA5}">
                      <a16:colId xmlns:a16="http://schemas.microsoft.com/office/drawing/2014/main" val="4141978141"/>
                    </a:ext>
                  </a:extLst>
                </a:gridCol>
                <a:gridCol w="1076663">
                  <a:extLst>
                    <a:ext uri="{9D8B030D-6E8A-4147-A177-3AD203B41FA5}">
                      <a16:colId xmlns:a16="http://schemas.microsoft.com/office/drawing/2014/main" val="280306914"/>
                    </a:ext>
                  </a:extLst>
                </a:gridCol>
                <a:gridCol w="979898">
                  <a:extLst>
                    <a:ext uri="{9D8B030D-6E8A-4147-A177-3AD203B41FA5}">
                      <a16:colId xmlns:a16="http://schemas.microsoft.com/office/drawing/2014/main" val="3865280829"/>
                    </a:ext>
                  </a:extLst>
                </a:gridCol>
                <a:gridCol w="682008">
                  <a:extLst>
                    <a:ext uri="{9D8B030D-6E8A-4147-A177-3AD203B41FA5}">
                      <a16:colId xmlns:a16="http://schemas.microsoft.com/office/drawing/2014/main" val="3243993411"/>
                    </a:ext>
                  </a:extLst>
                </a:gridCol>
              </a:tblGrid>
              <a:tr h="2351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Regression Analysi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</a:rPr>
                        <a:t>R</a:t>
                      </a:r>
                      <a:r>
                        <a:rPr lang="en-US" sz="1200" b="1" baseline="30000" dirty="0">
                          <a:solidFill>
                            <a:schemeClr val="tx1"/>
                          </a:solidFill>
                        </a:rPr>
                        <a:t>2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</a:rPr>
                        <a:t>Slope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tx1"/>
                          </a:solidFill>
                        </a:rPr>
                        <a:t>P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6752634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S1PRs</a:t>
                      </a: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4897848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/>
                        <a:t>Coronary flow of HDL (400ug) vs S1PR1 protein levels</a:t>
                      </a:r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**</a:t>
                      </a:r>
                      <a:endParaRPr lang="en-US" sz="1200" dirty="0"/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5869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-14.74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098</a:t>
                      </a:r>
                    </a:p>
                  </a:txBody>
                  <a:tcP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29881072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/>
                        <a:t>Coronary flow of HDL (400ug) + W146 vs S1PR1 protein leve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006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-0.6888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8274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84223895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28650" marR="0" lvl="0" indent="-268288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Coronary flow of HDL (400 ug) vs S1PR2 protein leve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305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-0.203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15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64478235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Coronary flow of HDL (400 ug) + JTE-013 vs S1PR2 protein leve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65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4339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54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2558204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/>
                        <a:t>Coronary flow of HDL (400ug) vs S1PR3 protein levels</a:t>
                      </a:r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**</a:t>
                      </a:r>
                      <a:endParaRPr lang="en-US" sz="12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662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2.51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04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1484377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/>
                        <a:t>Coronary flow of HDL (400ug) + CAY-10444 vs S1PR3 protein leve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387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3284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5858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2025296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dirty="0"/>
                        <a:t>Nitric oxide synthase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0930368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/>
                        <a:t>Coronary flow of HDL (400ug) vs Nitrite levels</a:t>
                      </a:r>
                      <a:r>
                        <a:rPr lang="en-US" sz="1200" dirty="0">
                          <a:solidFill>
                            <a:srgbClr val="FF0000"/>
                          </a:solidFill>
                        </a:rPr>
                        <a:t>*</a:t>
                      </a:r>
                      <a:endParaRPr lang="en-US" sz="12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492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351974149523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238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4309796"/>
                  </a:ext>
                </a:extLst>
              </a:tr>
              <a:tr h="235137">
                <a:tc>
                  <a:txBody>
                    <a:bodyPr/>
                    <a:lstStyle/>
                    <a:p>
                      <a:pPr marL="646113" marR="0" lvl="0" indent="-28575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Char char="•"/>
                        <a:tabLst/>
                        <a:defRPr/>
                      </a:pPr>
                      <a:r>
                        <a:rPr lang="en-US" sz="1200" dirty="0"/>
                        <a:t>Coronary flow of HDL (400ug) + L-NAME vs Nitrite levels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02213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41708468860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</a:rPr>
                        <a:t>0.6817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695657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2571A73-1D9B-43B2-AAE4-18FC5C51F95B}"/>
              </a:ext>
            </a:extLst>
          </p:cNvPr>
          <p:cNvSpPr txBox="1"/>
          <p:nvPr/>
        </p:nvSpPr>
        <p:spPr>
          <a:xfrm>
            <a:off x="150668" y="473193"/>
            <a:ext cx="101663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/>
              <a:t>Supplementary Table-S2</a:t>
            </a:r>
            <a:r>
              <a:rPr lang="en-US" sz="1200" b="1" dirty="0"/>
              <a:t>: Relationship between coronary flow and SRR-BI, S1PRs and nitrite levels in HDL treated hearts from WKY and SHR</a:t>
            </a:r>
            <a:r>
              <a:rPr lang="en-US" sz="1200" dirty="0"/>
              <a:t>.</a:t>
            </a:r>
          </a:p>
          <a:p>
            <a:r>
              <a:rPr lang="en-US" sz="1200" dirty="0"/>
              <a:t> * P&lt;0.05, **P&lt;0.001 </a:t>
            </a:r>
          </a:p>
        </p:txBody>
      </p:sp>
    </p:spTree>
    <p:extLst>
      <p:ext uri="{BB962C8B-B14F-4D97-AF65-F5344CB8AC3E}">
        <p14:creationId xmlns:p14="http://schemas.microsoft.com/office/powerpoint/2010/main" val="2068059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42</TotalTime>
  <Words>320</Words>
  <Application>Microsoft Office PowerPoint</Application>
  <PresentationFormat>Widescreen</PresentationFormat>
  <Paragraphs>7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Kuwait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shah Aljarallah</dc:creator>
  <cp:lastModifiedBy>MDPI-0905</cp:lastModifiedBy>
  <cp:revision>26</cp:revision>
  <dcterms:created xsi:type="dcterms:W3CDTF">2023-06-26T11:43:46Z</dcterms:created>
  <dcterms:modified xsi:type="dcterms:W3CDTF">2024-04-01T16:55:49Z</dcterms:modified>
</cp:coreProperties>
</file>